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946900" cy="9271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784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43055880"/>
        <c:axId val="1874191224"/>
      </c:barChart>
      <c:catAx>
        <c:axId val="1843055880"/>
        <c:scaling>
          <c:orientation val="minMax"/>
        </c:scaling>
        <c:delete val="0"/>
        <c:axPos val="b"/>
        <c:majorTickMark val="out"/>
        <c:minorTickMark val="none"/>
        <c:tickLblPos val="nextTo"/>
        <c:crossAx val="1874191224"/>
        <c:crosses val="autoZero"/>
        <c:auto val="1"/>
        <c:lblAlgn val="ctr"/>
        <c:lblOffset val="100"/>
        <c:noMultiLvlLbl val="0"/>
      </c:catAx>
      <c:valAx>
        <c:axId val="1874191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843055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4047372487492"/>
          <c:y val="0.045588885264103"/>
          <c:w val="0.735845095996043"/>
          <c:h val="0.82710900747496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'2nd repeat Pstabaci-Nt markaz'!$AB$30:$AB$31</c:f>
                <c:numCache>
                  <c:formatCode>General</c:formatCode>
                  <c:ptCount val="2"/>
                  <c:pt idx="0">
                    <c:v>0.0739099687214278</c:v>
                  </c:pt>
                  <c:pt idx="1">
                    <c:v>0.422197819877002</c:v>
                  </c:pt>
                </c:numCache>
              </c:numRef>
            </c:plus>
            <c:minus>
              <c:numRef>
                <c:f>'2nd repeat Pstabaci-Nt markaz'!$AB$30:$AB$31</c:f>
                <c:numCache>
                  <c:formatCode>General</c:formatCode>
                  <c:ptCount val="2"/>
                  <c:pt idx="0">
                    <c:v>0.0739099687214278</c:v>
                  </c:pt>
                  <c:pt idx="1">
                    <c:v>0.422197819877002</c:v>
                  </c:pt>
                </c:numCache>
              </c:numRef>
            </c:minus>
          </c:errBars>
          <c:cat>
            <c:strRef>
              <c:f>'2nd repeat Pstabaci-Nt markaz'!$AB$26:$AC$27</c:f>
              <c:strCache>
                <c:ptCount val="2"/>
                <c:pt idx="0">
                  <c:v>GFP</c:v>
                </c:pt>
                <c:pt idx="1">
                  <c:v>Pb3BSMT</c:v>
                </c:pt>
              </c:strCache>
            </c:strRef>
          </c:cat>
          <c:val>
            <c:numRef>
              <c:f>'2nd repeat Pstabaci-Nt markaz'!$AD$26:$AD$27</c:f>
              <c:numCache>
                <c:formatCode>General</c:formatCode>
                <c:ptCount val="2"/>
                <c:pt idx="0">
                  <c:v>12.23402671331127</c:v>
                </c:pt>
                <c:pt idx="1">
                  <c:v>11.59218221542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85808120"/>
        <c:axId val="2072110808"/>
      </c:barChart>
      <c:catAx>
        <c:axId val="1885808120"/>
        <c:scaling>
          <c:orientation val="minMax"/>
        </c:scaling>
        <c:delete val="0"/>
        <c:axPos val="b"/>
        <c:majorTickMark val="out"/>
        <c:minorTickMark val="none"/>
        <c:tickLblPos val="nextTo"/>
        <c:crossAx val="2072110808"/>
        <c:crosses val="autoZero"/>
        <c:auto val="1"/>
        <c:lblAlgn val="ctr"/>
        <c:lblOffset val="100"/>
        <c:noMultiLvlLbl val="0"/>
      </c:catAx>
      <c:valAx>
        <c:axId val="2072110808"/>
        <c:scaling>
          <c:orientation val="minMax"/>
          <c:max val="12.5"/>
          <c:min val="11.0"/>
        </c:scaling>
        <c:delete val="0"/>
        <c:axPos val="l"/>
        <c:numFmt formatCode="General" sourceLinked="1"/>
        <c:majorTickMark val="out"/>
        <c:minorTickMark val="none"/>
        <c:tickLblPos val="nextTo"/>
        <c:crossAx val="1885808120"/>
        <c:crosses val="autoZero"/>
        <c:crossBetween val="between"/>
        <c:majorUnit val="0.5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9002405949256"/>
          <c:y val="0.148622776319627"/>
          <c:w val="0.690442038495188"/>
          <c:h val="0.7128561730283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2nd repeat Pstabaci-Nt markaz'!$S$46:$S$47</c:f>
                <c:numCache>
                  <c:formatCode>General</c:formatCode>
                  <c:ptCount val="2"/>
                  <c:pt idx="0">
                    <c:v>0.232918281648147</c:v>
                  </c:pt>
                  <c:pt idx="1">
                    <c:v>0.150231303144333</c:v>
                  </c:pt>
                </c:numCache>
              </c:numRef>
            </c:plus>
            <c:minus>
              <c:numRef>
                <c:f>'2nd repeat Pstabaci-Nt markaz'!$S$46:$S$47</c:f>
                <c:numCache>
                  <c:formatCode>General</c:formatCode>
                  <c:ptCount val="2"/>
                  <c:pt idx="0">
                    <c:v>0.232918281648147</c:v>
                  </c:pt>
                  <c:pt idx="1">
                    <c:v>0.150231303144333</c:v>
                  </c:pt>
                </c:numCache>
              </c:numRef>
            </c:minus>
          </c:errBars>
          <c:cat>
            <c:strRef>
              <c:f>'2nd repeat Pstabaci-Nt markaz'!$R$43:$R$44</c:f>
              <c:strCache>
                <c:ptCount val="2"/>
                <c:pt idx="0">
                  <c:v>GFP</c:v>
                </c:pt>
                <c:pt idx="1">
                  <c:v>Pb3BSMT</c:v>
                </c:pt>
              </c:strCache>
            </c:strRef>
          </c:cat>
          <c:val>
            <c:numRef>
              <c:f>'2nd repeat Pstabaci-Nt markaz'!$S$43:$S$44</c:f>
              <c:numCache>
                <c:formatCode>General</c:formatCode>
                <c:ptCount val="2"/>
                <c:pt idx="0">
                  <c:v>0.939444444444443</c:v>
                </c:pt>
                <c:pt idx="1">
                  <c:v>0.41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44789672"/>
        <c:axId val="1844709848"/>
      </c:barChart>
      <c:catAx>
        <c:axId val="1844789672"/>
        <c:scaling>
          <c:orientation val="minMax"/>
        </c:scaling>
        <c:delete val="0"/>
        <c:axPos val="b"/>
        <c:majorTickMark val="out"/>
        <c:minorTickMark val="none"/>
        <c:tickLblPos val="nextTo"/>
        <c:crossAx val="1844709848"/>
        <c:crosses val="autoZero"/>
        <c:auto val="1"/>
        <c:lblAlgn val="ctr"/>
        <c:lblOffset val="100"/>
        <c:noMultiLvlLbl val="0"/>
      </c:catAx>
      <c:valAx>
        <c:axId val="1844709848"/>
        <c:scaling>
          <c:orientation val="minMax"/>
          <c:max val="1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1844789672"/>
        <c:crosses val="autoZero"/>
        <c:crossBetween val="between"/>
        <c:majorUnit val="0.2"/>
        <c:min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5002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310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3224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82651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35449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087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6580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945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1121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24216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8004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26D80-F145-4F23-89BC-472CD67BB73C}" type="datetimeFigureOut">
              <a:rPr lang="en-CA" smtClean="0"/>
              <a:t>16-03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0A356-A06B-4223-89BE-985E4644390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86717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chart" Target="../charts/chart2.xml"/><Relationship Id="rId6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267744" y="5661248"/>
            <a:ext cx="59046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GFP-induced/5*10^5                  Pb3BSMT- induced/5*10^5</a:t>
            </a:r>
            <a:endParaRPr lang="en-CA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1039133" y="1180728"/>
            <a:ext cx="25922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b="1" dirty="0" smtClean="0"/>
              <a:t>Log bacterial numbers (</a:t>
            </a:r>
            <a:r>
              <a:rPr lang="en-CA" sz="900" b="1" dirty="0" err="1" smtClean="0"/>
              <a:t>cfu</a:t>
            </a:r>
            <a:r>
              <a:rPr lang="en-CA" sz="900" b="1" dirty="0" smtClean="0"/>
              <a:t>/gram leaf disc)</a:t>
            </a:r>
            <a:endParaRPr lang="en-CA" sz="900" b="1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9578259"/>
              </p:ext>
            </p:extLst>
          </p:nvPr>
        </p:nvGraphicFramePr>
        <p:xfrm>
          <a:off x="5246752" y="332656"/>
          <a:ext cx="2596319" cy="2379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1"/>
          <p:cNvSpPr txBox="1"/>
          <p:nvPr/>
        </p:nvSpPr>
        <p:spPr>
          <a:xfrm rot="16200000">
            <a:off x="4390633" y="1001343"/>
            <a:ext cx="2592288" cy="39081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CA" sz="900" b="1" dirty="0" smtClean="0"/>
              <a:t>Differences in Lesion diameter (mm)</a:t>
            </a:r>
            <a:endParaRPr lang="en-CA" sz="9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283968" y="111147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2" name="TextBox 11"/>
          <p:cNvSpPr txBox="1"/>
          <p:nvPr/>
        </p:nvSpPr>
        <p:spPr>
          <a:xfrm>
            <a:off x="7388929" y="141277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pic>
        <p:nvPicPr>
          <p:cNvPr id="14" name="Picture 1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3783960"/>
            <a:ext cx="1590040" cy="17487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0367" y="3789040"/>
            <a:ext cx="1609090" cy="1743710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3061398"/>
              </p:ext>
            </p:extLst>
          </p:nvPr>
        </p:nvGraphicFramePr>
        <p:xfrm>
          <a:off x="2328846" y="773996"/>
          <a:ext cx="2714160" cy="18629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5072488"/>
              </p:ext>
            </p:extLst>
          </p:nvPr>
        </p:nvGraphicFramePr>
        <p:xfrm>
          <a:off x="5238328" y="551602"/>
          <a:ext cx="2934072" cy="209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23" name="Group 22"/>
          <p:cNvGrpSpPr/>
          <p:nvPr/>
        </p:nvGrpSpPr>
        <p:grpSpPr>
          <a:xfrm>
            <a:off x="2483768" y="5085184"/>
            <a:ext cx="576064" cy="288032"/>
            <a:chOff x="2483768" y="5085184"/>
            <a:chExt cx="576064" cy="288032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2555776" y="5373216"/>
              <a:ext cx="5040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2483768" y="5085184"/>
              <a:ext cx="53948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1 mm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5724128" y="5085184"/>
            <a:ext cx="576064" cy="288032"/>
            <a:chOff x="2483768" y="5085184"/>
            <a:chExt cx="576064" cy="288032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2555776" y="5373216"/>
              <a:ext cx="5040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2483768" y="5085184"/>
              <a:ext cx="53948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1 mm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220771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1</TotalTime>
  <Words>41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javaheri, Mohammad</dc:creator>
  <cp:lastModifiedBy>Hossein  Borhan</cp:lastModifiedBy>
  <cp:revision>14</cp:revision>
  <cp:lastPrinted>2015-07-27T16:52:41Z</cp:lastPrinted>
  <dcterms:created xsi:type="dcterms:W3CDTF">2015-07-27T16:22:59Z</dcterms:created>
  <dcterms:modified xsi:type="dcterms:W3CDTF">2016-03-02T20:40:49Z</dcterms:modified>
</cp:coreProperties>
</file>